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</p:sldIdLst>
  <p:sldSz cx="6858000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25" d="100"/>
          <a:sy n="125" d="100"/>
        </p:scale>
        <p:origin x="1157" y="-103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945943"/>
            <a:ext cx="5829300" cy="626689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9454516"/>
            <a:ext cx="5143500" cy="434599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CF310-BF7B-420E-AF61-BD8F932395FC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456DE-8CC0-4D8F-87BD-FE9E8DFDF7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11762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CF310-BF7B-420E-AF61-BD8F932395FC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456DE-8CC0-4D8F-87BD-FE9E8DFDF7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3821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958369"/>
            <a:ext cx="1478756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958369"/>
            <a:ext cx="4350544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CF310-BF7B-420E-AF61-BD8F932395FC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456DE-8CC0-4D8F-87BD-FE9E8DFDF7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03546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CF310-BF7B-420E-AF61-BD8F932395FC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456DE-8CC0-4D8F-87BD-FE9E8DFDF7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18205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4487671"/>
            <a:ext cx="5915025" cy="7487774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12046282"/>
            <a:ext cx="5915025" cy="393764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CF310-BF7B-420E-AF61-BD8F932395FC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456DE-8CC0-4D8F-87BD-FE9E8DFDF7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72145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4791843"/>
            <a:ext cx="2914650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4791843"/>
            <a:ext cx="2914650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CF310-BF7B-420E-AF61-BD8F932395FC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456DE-8CC0-4D8F-87BD-FE9E8DFDF7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1889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958373"/>
            <a:ext cx="5915025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4412664"/>
            <a:ext cx="2901255" cy="2162578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6575242"/>
            <a:ext cx="2901255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4412664"/>
            <a:ext cx="2915543" cy="2162578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6575242"/>
            <a:ext cx="291554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CF310-BF7B-420E-AF61-BD8F932395FC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456DE-8CC0-4D8F-87BD-FE9E8DFDF7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8085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CF310-BF7B-420E-AF61-BD8F932395FC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456DE-8CC0-4D8F-87BD-FE9E8DFDF7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45715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CF310-BF7B-420E-AF61-BD8F932395FC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456DE-8CC0-4D8F-87BD-FE9E8DFDF7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1959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1200044"/>
            <a:ext cx="2211884" cy="4200155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2591766"/>
            <a:ext cx="3471863" cy="1279213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5400199"/>
            <a:ext cx="2211884" cy="1000453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CF310-BF7B-420E-AF61-BD8F932395FC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456DE-8CC0-4D8F-87BD-FE9E8DFDF7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54849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1200044"/>
            <a:ext cx="2211884" cy="4200155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2591766"/>
            <a:ext cx="3471863" cy="12792138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5400199"/>
            <a:ext cx="2211884" cy="1000453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CF310-BF7B-420E-AF61-BD8F932395FC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456DE-8CC0-4D8F-87BD-FE9E8DFDF7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04741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958373"/>
            <a:ext cx="5915025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4791843"/>
            <a:ext cx="5915025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6683952"/>
            <a:ext cx="154305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3CF310-BF7B-420E-AF61-BD8F932395FC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6683952"/>
            <a:ext cx="231457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6683952"/>
            <a:ext cx="154305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E456DE-8CC0-4D8F-87BD-FE9E8DFDF7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9486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0" Type="http://schemas.openxmlformats.org/officeDocument/2006/relationships/image" Target="../media/image19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88F6AEAE-1BC6-4BB0-8451-A1C4807F53FC}"/>
              </a:ext>
            </a:extLst>
          </p:cNvPr>
          <p:cNvGrpSpPr/>
          <p:nvPr/>
        </p:nvGrpSpPr>
        <p:grpSpPr>
          <a:xfrm>
            <a:off x="209892" y="1391076"/>
            <a:ext cx="2169508" cy="1959104"/>
            <a:chOff x="159092" y="66427"/>
            <a:chExt cx="2169508" cy="1959104"/>
          </a:xfrm>
        </p:grpSpPr>
        <p:pic>
          <p:nvPicPr>
            <p:cNvPr id="43" name="图片 42">
              <a:extLst>
                <a:ext uri="{FF2B5EF4-FFF2-40B4-BE49-F238E27FC236}">
                  <a16:creationId xmlns:a16="http://schemas.microsoft.com/office/drawing/2014/main" id="{2FB1A8E7-B1BC-4357-8A74-1C42CBE52EA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66815" y="151181"/>
              <a:ext cx="2061785" cy="1874350"/>
            </a:xfrm>
            <a:prstGeom prst="rect">
              <a:avLst/>
            </a:prstGeom>
          </p:spPr>
        </p:pic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4CE1F1B6-D696-43FF-B88C-D5A55F940B91}"/>
                </a:ext>
              </a:extLst>
            </p:cNvPr>
            <p:cNvSpPr txBox="1"/>
            <p:nvPr/>
          </p:nvSpPr>
          <p:spPr>
            <a:xfrm>
              <a:off x="159092" y="66427"/>
              <a:ext cx="274320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" name="组合 2">
            <a:extLst>
              <a:ext uri="{FF2B5EF4-FFF2-40B4-BE49-F238E27FC236}">
                <a16:creationId xmlns:a16="http://schemas.microsoft.com/office/drawing/2014/main" id="{48BD37AF-B3B7-4019-B3D7-AFADB051F71C}"/>
              </a:ext>
            </a:extLst>
          </p:cNvPr>
          <p:cNvGrpSpPr/>
          <p:nvPr/>
        </p:nvGrpSpPr>
        <p:grpSpPr>
          <a:xfrm>
            <a:off x="2337846" y="1391078"/>
            <a:ext cx="2172850" cy="1951193"/>
            <a:chOff x="2287043" y="66427"/>
            <a:chExt cx="2172850" cy="1951193"/>
          </a:xfrm>
        </p:grpSpPr>
        <p:pic>
          <p:nvPicPr>
            <p:cNvPr id="41" name="图片 40">
              <a:extLst>
                <a:ext uri="{FF2B5EF4-FFF2-40B4-BE49-F238E27FC236}">
                  <a16:creationId xmlns:a16="http://schemas.microsoft.com/office/drawing/2014/main" id="{2C486453-EC1E-435F-9FDE-B0A9A6052BE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398108" y="143270"/>
              <a:ext cx="2061785" cy="1874350"/>
            </a:xfrm>
            <a:prstGeom prst="rect">
              <a:avLst/>
            </a:prstGeom>
          </p:spPr>
        </p:pic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C44B6AF8-98AA-46CD-A8F7-85EE157C0082}"/>
                </a:ext>
              </a:extLst>
            </p:cNvPr>
            <p:cNvSpPr txBox="1"/>
            <p:nvPr/>
          </p:nvSpPr>
          <p:spPr>
            <a:xfrm>
              <a:off x="2287043" y="66427"/>
              <a:ext cx="274320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" name="组合 3">
            <a:extLst>
              <a:ext uri="{FF2B5EF4-FFF2-40B4-BE49-F238E27FC236}">
                <a16:creationId xmlns:a16="http://schemas.microsoft.com/office/drawing/2014/main" id="{6061D375-DE15-4D47-8C62-7EAD9A191489}"/>
              </a:ext>
            </a:extLst>
          </p:cNvPr>
          <p:cNvGrpSpPr/>
          <p:nvPr/>
        </p:nvGrpSpPr>
        <p:grpSpPr>
          <a:xfrm>
            <a:off x="4481259" y="1391076"/>
            <a:ext cx="2198943" cy="1959104"/>
            <a:chOff x="4430456" y="66427"/>
            <a:chExt cx="2198943" cy="1959104"/>
          </a:xfrm>
        </p:grpSpPr>
        <p:pic>
          <p:nvPicPr>
            <p:cNvPr id="39" name="图片 38">
              <a:extLst>
                <a:ext uri="{FF2B5EF4-FFF2-40B4-BE49-F238E27FC236}">
                  <a16:creationId xmlns:a16="http://schemas.microsoft.com/office/drawing/2014/main" id="{B51BDFA9-600F-4353-B229-93D84D8B190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567616" y="151182"/>
              <a:ext cx="2061783" cy="1874349"/>
            </a:xfrm>
            <a:prstGeom prst="rect">
              <a:avLst/>
            </a:prstGeom>
          </p:spPr>
        </p:pic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8D2AB5E4-E3AA-4364-81A4-597993EDE123}"/>
                </a:ext>
              </a:extLst>
            </p:cNvPr>
            <p:cNvSpPr txBox="1"/>
            <p:nvPr/>
          </p:nvSpPr>
          <p:spPr>
            <a:xfrm>
              <a:off x="4430456" y="66427"/>
              <a:ext cx="274320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" name="组合 5">
            <a:extLst>
              <a:ext uri="{FF2B5EF4-FFF2-40B4-BE49-F238E27FC236}">
                <a16:creationId xmlns:a16="http://schemas.microsoft.com/office/drawing/2014/main" id="{5F157FA6-8F0D-4153-A4F7-D8B9BBA135FF}"/>
              </a:ext>
            </a:extLst>
          </p:cNvPr>
          <p:cNvGrpSpPr/>
          <p:nvPr/>
        </p:nvGrpSpPr>
        <p:grpSpPr>
          <a:xfrm>
            <a:off x="209891" y="3425524"/>
            <a:ext cx="2169509" cy="1962864"/>
            <a:chOff x="159090" y="2110285"/>
            <a:chExt cx="2169509" cy="1962864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9801B43F-A808-479D-92E2-AC14A394DC2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66815" y="2198800"/>
              <a:ext cx="2061784" cy="1874349"/>
            </a:xfrm>
            <a:prstGeom prst="rect">
              <a:avLst/>
            </a:prstGeom>
          </p:spPr>
        </p:pic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C96525C9-840D-42FC-8B68-1A1959C38CF7}"/>
                </a:ext>
              </a:extLst>
            </p:cNvPr>
            <p:cNvSpPr txBox="1"/>
            <p:nvPr/>
          </p:nvSpPr>
          <p:spPr>
            <a:xfrm>
              <a:off x="159090" y="2110285"/>
              <a:ext cx="274320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" name="组合 7">
            <a:extLst>
              <a:ext uri="{FF2B5EF4-FFF2-40B4-BE49-F238E27FC236}">
                <a16:creationId xmlns:a16="http://schemas.microsoft.com/office/drawing/2014/main" id="{4096EFF8-A620-468F-A771-F953F57EF5DE}"/>
              </a:ext>
            </a:extLst>
          </p:cNvPr>
          <p:cNvGrpSpPr/>
          <p:nvPr/>
        </p:nvGrpSpPr>
        <p:grpSpPr>
          <a:xfrm>
            <a:off x="2311750" y="3419111"/>
            <a:ext cx="2198943" cy="1969277"/>
            <a:chOff x="2260948" y="2094463"/>
            <a:chExt cx="2198943" cy="1969277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85D3983F-30BC-464E-B5D7-236B4985467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398108" y="2189391"/>
              <a:ext cx="2061783" cy="1874349"/>
            </a:xfrm>
            <a:prstGeom prst="rect">
              <a:avLst/>
            </a:prstGeom>
          </p:spPr>
        </p:pic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DD51AF41-F42D-44F4-9544-691EFDC31515}"/>
                </a:ext>
              </a:extLst>
            </p:cNvPr>
            <p:cNvSpPr txBox="1"/>
            <p:nvPr/>
          </p:nvSpPr>
          <p:spPr>
            <a:xfrm>
              <a:off x="2260948" y="2094463"/>
              <a:ext cx="274320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" name="组合 9">
            <a:extLst>
              <a:ext uri="{FF2B5EF4-FFF2-40B4-BE49-F238E27FC236}">
                <a16:creationId xmlns:a16="http://schemas.microsoft.com/office/drawing/2014/main" id="{45E91A87-BCB4-433F-B3C0-06EA1AA535C9}"/>
              </a:ext>
            </a:extLst>
          </p:cNvPr>
          <p:cNvGrpSpPr/>
          <p:nvPr/>
        </p:nvGrpSpPr>
        <p:grpSpPr>
          <a:xfrm>
            <a:off x="4465088" y="3419113"/>
            <a:ext cx="2215112" cy="1975217"/>
            <a:chOff x="4414286" y="2094463"/>
            <a:chExt cx="2215112" cy="1975217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3D182338-8201-478A-B788-E10C407E57D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567616" y="2195332"/>
              <a:ext cx="2061782" cy="1874348"/>
            </a:xfrm>
            <a:prstGeom prst="rect">
              <a:avLst/>
            </a:prstGeom>
          </p:spPr>
        </p:pic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3F48E412-FEC0-469F-98BB-2D2AB8840473}"/>
                </a:ext>
              </a:extLst>
            </p:cNvPr>
            <p:cNvSpPr txBox="1"/>
            <p:nvPr/>
          </p:nvSpPr>
          <p:spPr>
            <a:xfrm>
              <a:off x="4414286" y="2094463"/>
              <a:ext cx="274320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604A987C-E3AC-4B43-8B7A-5FE47314D8F0}"/>
              </a:ext>
            </a:extLst>
          </p:cNvPr>
          <p:cNvGrpSpPr/>
          <p:nvPr/>
        </p:nvGrpSpPr>
        <p:grpSpPr>
          <a:xfrm>
            <a:off x="209890" y="5447148"/>
            <a:ext cx="2204114" cy="1995509"/>
            <a:chOff x="159090" y="4122499"/>
            <a:chExt cx="2204114" cy="1995509"/>
          </a:xfrm>
        </p:grpSpPr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59427E4E-6B1E-4E8A-84FB-6C49E3EBA2B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01419" y="4243658"/>
              <a:ext cx="2061785" cy="1874350"/>
            </a:xfrm>
            <a:prstGeom prst="rect">
              <a:avLst/>
            </a:prstGeom>
          </p:spPr>
        </p:pic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C5B44CAA-DE20-462C-8B2E-F4850627F1C7}"/>
                </a:ext>
              </a:extLst>
            </p:cNvPr>
            <p:cNvSpPr txBox="1"/>
            <p:nvPr/>
          </p:nvSpPr>
          <p:spPr>
            <a:xfrm>
              <a:off x="159090" y="4122499"/>
              <a:ext cx="274320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CABC2A2A-3B65-41ED-A921-2F1A574CC08E}"/>
              </a:ext>
            </a:extLst>
          </p:cNvPr>
          <p:cNvGrpSpPr/>
          <p:nvPr/>
        </p:nvGrpSpPr>
        <p:grpSpPr>
          <a:xfrm>
            <a:off x="2317682" y="5447148"/>
            <a:ext cx="2199203" cy="1995509"/>
            <a:chOff x="2266877" y="4122499"/>
            <a:chExt cx="2199203" cy="1995509"/>
          </a:xfrm>
        </p:grpSpPr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8860D348-7ED8-4592-A2B0-A89A7BF3F18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404297" y="4243659"/>
              <a:ext cx="2061783" cy="1874349"/>
            </a:xfrm>
            <a:prstGeom prst="rect">
              <a:avLst/>
            </a:prstGeom>
          </p:spPr>
        </p:pic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111A5FD7-8712-473B-BD79-4842A519E6E0}"/>
                </a:ext>
              </a:extLst>
            </p:cNvPr>
            <p:cNvSpPr txBox="1"/>
            <p:nvPr/>
          </p:nvSpPr>
          <p:spPr>
            <a:xfrm>
              <a:off x="2266877" y="4122499"/>
              <a:ext cx="274320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" name="组合 12">
            <a:extLst>
              <a:ext uri="{FF2B5EF4-FFF2-40B4-BE49-F238E27FC236}">
                <a16:creationId xmlns:a16="http://schemas.microsoft.com/office/drawing/2014/main" id="{6AFA641A-8527-43A8-9AD4-58EA46CEC713}"/>
              </a:ext>
            </a:extLst>
          </p:cNvPr>
          <p:cNvGrpSpPr/>
          <p:nvPr/>
        </p:nvGrpSpPr>
        <p:grpSpPr>
          <a:xfrm>
            <a:off x="4481257" y="5447148"/>
            <a:ext cx="2123504" cy="1991329"/>
            <a:chOff x="4430456" y="4122499"/>
            <a:chExt cx="2123504" cy="1991329"/>
          </a:xfrm>
        </p:grpSpPr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0481C5B9-F266-42E8-8CA1-D4853AA47476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492179" y="4239481"/>
              <a:ext cx="2061781" cy="1874347"/>
            </a:xfrm>
            <a:prstGeom prst="rect">
              <a:avLst/>
            </a:prstGeom>
          </p:spPr>
        </p:pic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41E673B2-BE6D-4ADB-BA54-7C27CDAD1819}"/>
                </a:ext>
              </a:extLst>
            </p:cNvPr>
            <p:cNvSpPr txBox="1"/>
            <p:nvPr/>
          </p:nvSpPr>
          <p:spPr>
            <a:xfrm>
              <a:off x="4430456" y="4122499"/>
              <a:ext cx="274320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2" name="组合 31">
            <a:extLst>
              <a:ext uri="{FF2B5EF4-FFF2-40B4-BE49-F238E27FC236}">
                <a16:creationId xmlns:a16="http://schemas.microsoft.com/office/drawing/2014/main" id="{4070F95D-8403-4B13-8198-AD0FDA66AD79}"/>
              </a:ext>
            </a:extLst>
          </p:cNvPr>
          <p:cNvGrpSpPr/>
          <p:nvPr/>
        </p:nvGrpSpPr>
        <p:grpSpPr>
          <a:xfrm>
            <a:off x="209890" y="7459359"/>
            <a:ext cx="2204112" cy="2028152"/>
            <a:chOff x="159090" y="6134713"/>
            <a:chExt cx="2204112" cy="2028152"/>
          </a:xfrm>
        </p:grpSpPr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AA6E8E7E-1D7D-4D39-845F-CACE5986CC7B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01419" y="6288516"/>
              <a:ext cx="2061783" cy="1874349"/>
            </a:xfrm>
            <a:prstGeom prst="rect">
              <a:avLst/>
            </a:prstGeom>
          </p:spPr>
        </p:pic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430E4F84-5038-4B7A-AFC2-22C7A5057E8A}"/>
                </a:ext>
              </a:extLst>
            </p:cNvPr>
            <p:cNvSpPr txBox="1"/>
            <p:nvPr/>
          </p:nvSpPr>
          <p:spPr>
            <a:xfrm>
              <a:off x="159090" y="6134713"/>
              <a:ext cx="274320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J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3" name="组合 32">
            <a:extLst>
              <a:ext uri="{FF2B5EF4-FFF2-40B4-BE49-F238E27FC236}">
                <a16:creationId xmlns:a16="http://schemas.microsoft.com/office/drawing/2014/main" id="{0FCB9B67-278E-4F5E-A985-8C4CCF5205D4}"/>
              </a:ext>
            </a:extLst>
          </p:cNvPr>
          <p:cNvGrpSpPr/>
          <p:nvPr/>
        </p:nvGrpSpPr>
        <p:grpSpPr>
          <a:xfrm>
            <a:off x="2313806" y="7459359"/>
            <a:ext cx="2222985" cy="2028152"/>
            <a:chOff x="2263001" y="6134713"/>
            <a:chExt cx="2222985" cy="2028152"/>
          </a:xfrm>
        </p:grpSpPr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31068FE4-034A-4F02-B4A3-8092ADFFBB53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424203" y="6288516"/>
              <a:ext cx="2061783" cy="1874349"/>
            </a:xfrm>
            <a:prstGeom prst="rect">
              <a:avLst/>
            </a:prstGeom>
          </p:spPr>
        </p:pic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41D4E571-4274-4B32-B690-B317CC9F71C1}"/>
                </a:ext>
              </a:extLst>
            </p:cNvPr>
            <p:cNvSpPr txBox="1"/>
            <p:nvPr/>
          </p:nvSpPr>
          <p:spPr>
            <a:xfrm>
              <a:off x="2263001" y="6134713"/>
              <a:ext cx="274320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4" name="组合 33">
            <a:extLst>
              <a:ext uri="{FF2B5EF4-FFF2-40B4-BE49-F238E27FC236}">
                <a16:creationId xmlns:a16="http://schemas.microsoft.com/office/drawing/2014/main" id="{86B6AAA2-2454-4E72-84B5-7BF021BAECF7}"/>
              </a:ext>
            </a:extLst>
          </p:cNvPr>
          <p:cNvGrpSpPr/>
          <p:nvPr/>
        </p:nvGrpSpPr>
        <p:grpSpPr>
          <a:xfrm>
            <a:off x="4456538" y="7459359"/>
            <a:ext cx="2203032" cy="2028152"/>
            <a:chOff x="4405736" y="6134713"/>
            <a:chExt cx="2203032" cy="2028152"/>
          </a:xfrm>
        </p:grpSpPr>
        <p:pic>
          <p:nvPicPr>
            <p:cNvPr id="29" name="图片 28">
              <a:extLst>
                <a:ext uri="{FF2B5EF4-FFF2-40B4-BE49-F238E27FC236}">
                  <a16:creationId xmlns:a16="http://schemas.microsoft.com/office/drawing/2014/main" id="{1E614FE2-BA75-4903-A87D-DBC1869770CB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546987" y="6288518"/>
              <a:ext cx="2061781" cy="1874347"/>
            </a:xfrm>
            <a:prstGeom prst="rect">
              <a:avLst/>
            </a:prstGeom>
          </p:spPr>
        </p:pic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2F160877-834A-47DE-8879-F360D8D54E90}"/>
                </a:ext>
              </a:extLst>
            </p:cNvPr>
            <p:cNvSpPr txBox="1"/>
            <p:nvPr/>
          </p:nvSpPr>
          <p:spPr>
            <a:xfrm>
              <a:off x="4405736" y="6134713"/>
              <a:ext cx="274320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38" name="图片 37">
            <a:extLst>
              <a:ext uri="{FF2B5EF4-FFF2-40B4-BE49-F238E27FC236}">
                <a16:creationId xmlns:a16="http://schemas.microsoft.com/office/drawing/2014/main" id="{2CB04B65-852E-4490-819D-0E2DCB9BE7F1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87867" y="11809188"/>
            <a:ext cx="2061781" cy="1874347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01AF4D63-1BBE-441F-82C6-0D712177552E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419160" y="11809186"/>
            <a:ext cx="2061781" cy="1874347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2B143F6D-BBD6-4BD6-8F58-82E24EFDDFAC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597789" y="11809185"/>
            <a:ext cx="2061781" cy="1874347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0CC0C9EF-8EC3-46BF-A9B6-F3E39D8A57A4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588662" y="9760745"/>
            <a:ext cx="2061782" cy="1874348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D653C9F2-19D5-40F3-A880-A514375ECF4F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419155" y="9760745"/>
            <a:ext cx="2061782" cy="1874348"/>
          </a:xfrm>
          <a:prstGeom prst="rect">
            <a:avLst/>
          </a:prstGeom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C7FED2F1-4C2D-4C2B-81FD-1A36E2071051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96987" y="9760750"/>
            <a:ext cx="2061781" cy="1874347"/>
          </a:xfrm>
          <a:prstGeom prst="rect">
            <a:avLst/>
          </a:prstGeom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88809489-6DB4-47A9-A16F-C2A256B22CE5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87867" y="13838842"/>
            <a:ext cx="2061781" cy="1874347"/>
          </a:xfrm>
          <a:prstGeom prst="rect">
            <a:avLst/>
          </a:prstGeom>
        </p:spPr>
      </p:pic>
      <p:sp>
        <p:nvSpPr>
          <p:cNvPr id="48" name="文本框 47">
            <a:extLst>
              <a:ext uri="{FF2B5EF4-FFF2-40B4-BE49-F238E27FC236}">
                <a16:creationId xmlns:a16="http://schemas.microsoft.com/office/drawing/2014/main" id="{FD17EF8F-013A-43E8-9DC5-32FE742A3A32}"/>
              </a:ext>
            </a:extLst>
          </p:cNvPr>
          <p:cNvSpPr txBox="1"/>
          <p:nvPr/>
        </p:nvSpPr>
        <p:spPr>
          <a:xfrm>
            <a:off x="203806" y="9609687"/>
            <a:ext cx="274320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F98F3C47-E072-4BD2-A8DB-FFC908C83E26}"/>
              </a:ext>
            </a:extLst>
          </p:cNvPr>
          <p:cNvSpPr txBox="1"/>
          <p:nvPr/>
        </p:nvSpPr>
        <p:spPr>
          <a:xfrm>
            <a:off x="2331757" y="9609687"/>
            <a:ext cx="274320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46BFB4C5-6744-4B49-9D25-D4409BF751DA}"/>
              </a:ext>
            </a:extLst>
          </p:cNvPr>
          <p:cNvSpPr txBox="1"/>
          <p:nvPr/>
        </p:nvSpPr>
        <p:spPr>
          <a:xfrm>
            <a:off x="4475170" y="9609687"/>
            <a:ext cx="274320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7A3E9F21-57E9-4DFC-A99F-DEA2A09B8E27}"/>
              </a:ext>
            </a:extLst>
          </p:cNvPr>
          <p:cNvSpPr txBox="1"/>
          <p:nvPr/>
        </p:nvSpPr>
        <p:spPr>
          <a:xfrm>
            <a:off x="203804" y="11653546"/>
            <a:ext cx="274320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0CE8E6CB-ECB1-48FB-8360-1F0A604D5BA7}"/>
              </a:ext>
            </a:extLst>
          </p:cNvPr>
          <p:cNvSpPr txBox="1"/>
          <p:nvPr/>
        </p:nvSpPr>
        <p:spPr>
          <a:xfrm>
            <a:off x="2305663" y="11637724"/>
            <a:ext cx="274320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E13DB964-A130-4EFA-958D-5AF07B16EABE}"/>
              </a:ext>
            </a:extLst>
          </p:cNvPr>
          <p:cNvSpPr txBox="1"/>
          <p:nvPr/>
        </p:nvSpPr>
        <p:spPr>
          <a:xfrm>
            <a:off x="4459002" y="11637724"/>
            <a:ext cx="274320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36D0A164-57E2-4C15-BF8B-99AAC646C036}"/>
              </a:ext>
            </a:extLst>
          </p:cNvPr>
          <p:cNvSpPr txBox="1"/>
          <p:nvPr/>
        </p:nvSpPr>
        <p:spPr>
          <a:xfrm>
            <a:off x="203804" y="13665759"/>
            <a:ext cx="274320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5B443C93-786A-40A1-82EF-346DDB68C8CD}"/>
              </a:ext>
            </a:extLst>
          </p:cNvPr>
          <p:cNvSpPr txBox="1"/>
          <p:nvPr/>
        </p:nvSpPr>
        <p:spPr>
          <a:xfrm>
            <a:off x="542719" y="16201666"/>
            <a:ext cx="61374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>
              <a:spcBef>
                <a:spcPts val="600"/>
              </a:spcBef>
              <a:spcAft>
                <a:spcPts val="1200"/>
              </a:spcAft>
            </a:pPr>
            <a:r>
              <a:rPr lang="en-US" altLang="zh-CN" sz="18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2. 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altLang="zh-CN" sz="18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altLang="zh-CN" sz="18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</a:t>
            </a:r>
            <a:r>
              <a:rPr lang="en-US" altLang="zh-CN" sz="18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rrelation Plot for Immune Cell Clinical Stage.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58529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54</TotalTime>
  <Words>34</Words>
  <Application>Microsoft Office PowerPoint</Application>
  <PresentationFormat>Custom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思涵</dc:creator>
  <cp:lastModifiedBy>MDPI</cp:lastModifiedBy>
  <cp:revision>39</cp:revision>
  <dcterms:created xsi:type="dcterms:W3CDTF">2022-01-16T07:53:43Z</dcterms:created>
  <dcterms:modified xsi:type="dcterms:W3CDTF">2022-08-30T11:08:24Z</dcterms:modified>
</cp:coreProperties>
</file>